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9144000" cy="6858000" type="screen4x3"/>
  <p:notesSz cx="6797675" cy="98567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138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78208711-2914-4B2C-9882-B292E4962A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xmlns="" id="{936B0FB3-410D-46AC-89FA-9A073BC861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93783D90-DCFA-4155-BEA8-A07076F9FA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E502B-D19C-47AA-93D3-BC5F0A599549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F58E2605-E988-433F-BB96-D95E8B919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1C901815-5923-4B29-A85F-EFDB546C6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66CA-9044-4391-9000-053CA1ECB2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391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9994DA68-C6B0-44B0-8ED6-DCBA67A2EB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954AC77C-13DE-4AF5-A53A-08DCE94063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F539D234-742A-4E9D-A735-C46C1D4DDB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E502B-D19C-47AA-93D3-BC5F0A599549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7161D611-5371-45D6-BC87-CB863D6FE2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DCEB1376-907F-46D5-9B87-24818B46A2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66CA-9044-4391-9000-053CA1ECB2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922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xmlns="" id="{017A5CF3-7394-4B25-9F2B-CC2ED30CB2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02B3C648-69CD-4439-ABE8-7C1D05827F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E6775D62-A41B-4BFD-92B4-4DA8A1E50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E502B-D19C-47AA-93D3-BC5F0A599549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4B0D85E1-57F6-4F00-BBC1-ABDF5461A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95741E09-44F5-4BDF-A0BA-DF0D883E1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66CA-9044-4391-9000-053CA1ECB2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934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819F6FDB-0639-4D92-9AEA-3E9D9D7592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0795C360-9460-401B-B40C-F258825744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13F878A4-9962-4227-B4FE-79BCD50F02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E502B-D19C-47AA-93D3-BC5F0A599549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0A73BDDC-420E-4F1B-97A3-2C0766355B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0C6460AC-339A-4419-8AF4-4E5F252382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66CA-9044-4391-9000-053CA1ECB2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510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B8F059F6-585E-43A9-8574-951F573F49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E1831C6A-82B8-4126-8429-26B9B7842E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45D50109-FF91-49FA-B490-A36E02C0A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E502B-D19C-47AA-93D3-BC5F0A599549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4A2570EB-0A60-407A-BEFE-FD77593CBC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6BD73C74-EFE4-4CAF-91BC-52E83CC75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66CA-9044-4391-9000-053CA1ECB2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660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79C286A6-50AB-4F27-83C8-021AB7ADB3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D0F3DDEF-D4EB-48F9-B40D-6572CE3EEE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8E6E51FA-9B75-4243-9F5A-77BF41DDDB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0DCE5EC8-68DD-495B-9E73-DA48CBD378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E502B-D19C-47AA-93D3-BC5F0A599549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DD6CDEC7-078B-4219-9AE0-ED6E8D968E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36C23538-B057-43E5-91F6-6ABF9B60C1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66CA-9044-4391-9000-053CA1ECB2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282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0E488E1E-CD8F-4B07-A991-11393BA4EE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925562C7-B797-4B15-8ED0-37385CDD9A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604B3681-44D9-44CB-9E7D-EE6FB9AEB0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xmlns="" id="{AAD75C3A-0FF6-42AC-AF55-4055D4A3F4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xmlns="" id="{186A8DA1-11F1-4A9D-9BC4-F591F52C9E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xmlns="" id="{1A1A3899-00CE-4B78-99A7-F43161BC8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E502B-D19C-47AA-93D3-BC5F0A599549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xmlns="" id="{D46E74FE-2BD9-4AF3-B105-D568EA46BC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xmlns="" id="{241E5956-65F7-4610-B179-CD35DB772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66CA-9044-4391-9000-053CA1ECB2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636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72763717-81A5-4874-80FE-554C19AC9A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xmlns="" id="{97494E2F-0B09-4746-8DAB-A523241660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E502B-D19C-47AA-93D3-BC5F0A599549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xmlns="" id="{576E55CE-85A2-470B-A4E3-4BE568BA2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xmlns="" id="{A2B9FE16-6A52-4A35-AE54-1FBC921ED5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66CA-9044-4391-9000-053CA1ECB2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740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xmlns="" id="{D68DF13F-DD09-4B11-BE0A-AA40EFF69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E502B-D19C-47AA-93D3-BC5F0A599549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xmlns="" id="{EAC82C65-0DDC-4E1C-9B54-160E80E390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xmlns="" id="{1C374041-20E0-44B8-88B9-C3BBB38C8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66CA-9044-4391-9000-053CA1ECB2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1366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AA571AF4-04CF-4597-8C85-ED39558AFA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E7986C8C-F6A0-4610-9DCA-531A2D993F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47809199-2DCF-4CC6-9B99-8D1ABF53FD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81CE86C1-B255-4028-A70F-0C0576792A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E502B-D19C-47AA-93D3-BC5F0A599549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C1B42E69-99E8-4D5D-B876-DD442459C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AD9F8841-A727-4238-A8AC-7BCFD0A89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66CA-9044-4391-9000-053CA1ECB2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600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2A9DA7AD-AB5B-42EC-8B2C-B9FA5021B3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xmlns="" id="{DFB18403-B4B6-4854-A2A7-7CFD907612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8D685199-9C24-418A-ABCD-B758CA9C18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5EABA8F6-55FE-4D6D-A4B2-11B9A2012F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E502B-D19C-47AA-93D3-BC5F0A599549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E0BD5CFF-1300-4657-87D6-BDB356CDC9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09F14DEB-7996-4885-98CA-1BAC58FBE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66CA-9044-4391-9000-053CA1ECB2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504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xmlns="" id="{808B1948-A54C-40B7-B2A3-7D82144814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8812F10F-ADF3-46A7-AB2D-595523C698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9A1E0B0D-7B38-4A77-AEB5-751CBF237A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AE502B-D19C-47AA-93D3-BC5F0A599549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1962925D-0D08-4A48-A7DF-B37B62D253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E8B7DD44-8B7A-43E3-9728-0D9A267096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E466CA-9044-4391-9000-053CA1ECB2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5525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feld 29">
            <a:extLst>
              <a:ext uri="{FF2B5EF4-FFF2-40B4-BE49-F238E27FC236}">
                <a16:creationId xmlns:a16="http://schemas.microsoft.com/office/drawing/2014/main" xmlns="" id="{9E0AEEC0-2346-4696-816E-40252198261F}"/>
              </a:ext>
            </a:extLst>
          </p:cNvPr>
          <p:cNvSpPr txBox="1"/>
          <p:nvPr/>
        </p:nvSpPr>
        <p:spPr>
          <a:xfrm>
            <a:off x="147294" y="104175"/>
            <a:ext cx="15811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hteck 58">
            <a:extLst>
              <a:ext uri="{FF2B5EF4-FFF2-40B4-BE49-F238E27FC236}">
                <a16:creationId xmlns:a16="http://schemas.microsoft.com/office/drawing/2014/main" xmlns="" id="{69FC0B82-018C-4AE1-8E36-66159ABB2DA8}"/>
              </a:ext>
            </a:extLst>
          </p:cNvPr>
          <p:cNvSpPr/>
          <p:nvPr/>
        </p:nvSpPr>
        <p:spPr>
          <a:xfrm>
            <a:off x="309966" y="5397113"/>
            <a:ext cx="852406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: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Unsupervised hierarchical clustering of methylation profiles separate PFSE tumors according to TERT mutation and chromosome 6 status.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xmlns="" id="{12029E84-B757-4B20-A602-5B5F06AC2AF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8318"/>
          <a:stretch/>
        </p:blipFill>
        <p:spPr>
          <a:xfrm>
            <a:off x="5481198" y="739760"/>
            <a:ext cx="385395" cy="3751263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xmlns="" id="{84EBB3FD-CD6E-4864-8BCB-0A1DA27AE7A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28444" y="722223"/>
            <a:ext cx="3784600" cy="4477718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xmlns="" id="{3AA781E2-DF7D-44A4-B4C1-4D354F9BA2D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217607" y="2030323"/>
            <a:ext cx="1006447" cy="547761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xmlns="" id="{8F24928B-E2EF-4ED0-9E99-BD4A4FBA302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41028"/>
          <a:stretch/>
        </p:blipFill>
        <p:spPr>
          <a:xfrm>
            <a:off x="6217606" y="2578084"/>
            <a:ext cx="1006447" cy="1001714"/>
          </a:xfrm>
          <a:prstGeom prst="rect">
            <a:avLst/>
          </a:prstGeom>
        </p:spPr>
      </p:pic>
      <p:sp>
        <p:nvSpPr>
          <p:cNvPr id="9" name="Rechteck 8">
            <a:extLst>
              <a:ext uri="{FF2B5EF4-FFF2-40B4-BE49-F238E27FC236}">
                <a16:creationId xmlns:a16="http://schemas.microsoft.com/office/drawing/2014/main" xmlns="" id="{5E605CFF-A100-43BC-B2FE-69A35607FB06}"/>
              </a:ext>
            </a:extLst>
          </p:cNvPr>
          <p:cNvSpPr/>
          <p:nvPr/>
        </p:nvSpPr>
        <p:spPr>
          <a:xfrm>
            <a:off x="3486758" y="739760"/>
            <a:ext cx="2409399" cy="2168525"/>
          </a:xfrm>
          <a:prstGeom prst="rect">
            <a:avLst/>
          </a:prstGeom>
          <a:solidFill>
            <a:srgbClr val="F0B372">
              <a:alpha val="1176"/>
            </a:srgbClr>
          </a:solidFill>
          <a:ln w="952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hteck 9">
            <a:extLst>
              <a:ext uri="{FF2B5EF4-FFF2-40B4-BE49-F238E27FC236}">
                <a16:creationId xmlns:a16="http://schemas.microsoft.com/office/drawing/2014/main" xmlns="" id="{D0767DDF-7A9F-4B74-A4A3-3217D9752EB9}"/>
              </a:ext>
            </a:extLst>
          </p:cNvPr>
          <p:cNvSpPr/>
          <p:nvPr/>
        </p:nvSpPr>
        <p:spPr>
          <a:xfrm>
            <a:off x="3486124" y="2908284"/>
            <a:ext cx="2410033" cy="1566864"/>
          </a:xfrm>
          <a:prstGeom prst="rect">
            <a:avLst/>
          </a:prstGeom>
          <a:solidFill>
            <a:srgbClr val="689FA1">
              <a:alpha val="5098"/>
            </a:srgbClr>
          </a:solidFill>
          <a:ln w="952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xmlns="" id="{3D7BEE80-EB99-4F42-9F27-6BA3C8F42521}"/>
              </a:ext>
            </a:extLst>
          </p:cNvPr>
          <p:cNvSpPr txBox="1"/>
          <p:nvPr/>
        </p:nvSpPr>
        <p:spPr>
          <a:xfrm>
            <a:off x="3486123" y="788878"/>
            <a:ext cx="702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luster 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FBB6A009-4EEF-425B-8129-273F0566D308}"/>
              </a:ext>
            </a:extLst>
          </p:cNvPr>
          <p:cNvSpPr txBox="1"/>
          <p:nvPr/>
        </p:nvSpPr>
        <p:spPr>
          <a:xfrm>
            <a:off x="3445883" y="2930116"/>
            <a:ext cx="702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luster 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xmlns="" id="{BACD1351-57D3-49E9-B2DE-C9993E66DE72}"/>
              </a:ext>
            </a:extLst>
          </p:cNvPr>
          <p:cNvSpPr txBox="1"/>
          <p:nvPr/>
        </p:nvSpPr>
        <p:spPr>
          <a:xfrm rot="16200000">
            <a:off x="5287969" y="4675470"/>
            <a:ext cx="839226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900"/>
              </a:lnSpc>
            </a:pP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Histology</a:t>
            </a:r>
          </a:p>
          <a:p>
            <a:pPr algn="r">
              <a:lnSpc>
                <a:spcPts val="900"/>
              </a:lnSpc>
            </a:pP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CNV</a:t>
            </a:r>
          </a:p>
          <a:p>
            <a:pPr algn="r">
              <a:lnSpc>
                <a:spcPts val="900"/>
              </a:lnSpc>
            </a:pP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TERT</a:t>
            </a:r>
          </a:p>
        </p:txBody>
      </p:sp>
    </p:spTree>
    <p:extLst>
      <p:ext uri="{BB962C8B-B14F-4D97-AF65-F5344CB8AC3E}">
        <p14:creationId xmlns:p14="http://schemas.microsoft.com/office/powerpoint/2010/main" val="25612866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feld 29">
            <a:extLst>
              <a:ext uri="{FF2B5EF4-FFF2-40B4-BE49-F238E27FC236}">
                <a16:creationId xmlns:a16="http://schemas.microsoft.com/office/drawing/2014/main" xmlns="" id="{9E0AEEC0-2346-4696-816E-40252198261F}"/>
              </a:ext>
            </a:extLst>
          </p:cNvPr>
          <p:cNvSpPr txBox="1"/>
          <p:nvPr/>
        </p:nvSpPr>
        <p:spPr>
          <a:xfrm>
            <a:off x="147294" y="104175"/>
            <a:ext cx="15811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hteck 60">
            <a:extLst>
              <a:ext uri="{FF2B5EF4-FFF2-40B4-BE49-F238E27FC236}">
                <a16:creationId xmlns:a16="http://schemas.microsoft.com/office/drawing/2014/main" xmlns="" id="{ACCEEC24-E53F-4BE2-9724-BE2DDF28121D}"/>
              </a:ext>
            </a:extLst>
          </p:cNvPr>
          <p:cNvSpPr/>
          <p:nvPr/>
        </p:nvSpPr>
        <p:spPr>
          <a:xfrm>
            <a:off x="309965" y="5663813"/>
            <a:ext cx="852406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: P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rogression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-free and overall survival of 49 PFSE tumors. 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Grafik 8">
            <a:extLst>
              <a:ext uri="{FF2B5EF4-FFF2-40B4-BE49-F238E27FC236}">
                <a16:creationId xmlns:a16="http://schemas.microsoft.com/office/drawing/2014/main" xmlns="" id="{63787F4E-C600-418A-9B45-463874F0449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696"/>
          <a:stretch/>
        </p:blipFill>
        <p:spPr>
          <a:xfrm>
            <a:off x="432182" y="1343222"/>
            <a:ext cx="4139816" cy="3714785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xmlns="" id="{B0DE068E-9DE3-436C-8908-FC1A6F12D43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696"/>
          <a:stretch/>
        </p:blipFill>
        <p:spPr>
          <a:xfrm>
            <a:off x="4699062" y="1343221"/>
            <a:ext cx="4134970" cy="3714785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1B920CFF-8DA1-493A-BC3F-0EF642B59834}"/>
              </a:ext>
            </a:extLst>
          </p:cNvPr>
          <p:cNvSpPr txBox="1"/>
          <p:nvPr/>
        </p:nvSpPr>
        <p:spPr>
          <a:xfrm>
            <a:off x="937869" y="1044884"/>
            <a:ext cx="3507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Progression-</a:t>
            </a:r>
            <a:r>
              <a:rPr lang="de-DE" dirty="0" err="1"/>
              <a:t>free</a:t>
            </a:r>
            <a:r>
              <a:rPr lang="de-DE" dirty="0"/>
              <a:t> </a:t>
            </a:r>
            <a:r>
              <a:rPr lang="de-DE" dirty="0" err="1"/>
              <a:t>survival</a:t>
            </a:r>
            <a:endParaRPr lang="en-US" dirty="0"/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xmlns="" id="{0754B60F-BBC3-4864-BFC8-8991DDE8FCAD}"/>
              </a:ext>
            </a:extLst>
          </p:cNvPr>
          <p:cNvSpPr txBox="1"/>
          <p:nvPr/>
        </p:nvSpPr>
        <p:spPr>
          <a:xfrm>
            <a:off x="5326962" y="1044884"/>
            <a:ext cx="3507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Overall </a:t>
            </a:r>
            <a:r>
              <a:rPr lang="de-DE" dirty="0" err="1"/>
              <a:t>surviva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06921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feld 29">
            <a:extLst>
              <a:ext uri="{FF2B5EF4-FFF2-40B4-BE49-F238E27FC236}">
                <a16:creationId xmlns:a16="http://schemas.microsoft.com/office/drawing/2014/main" xmlns="" id="{9E0AEEC0-2346-4696-816E-40252198261F}"/>
              </a:ext>
            </a:extLst>
          </p:cNvPr>
          <p:cNvSpPr txBox="1"/>
          <p:nvPr/>
        </p:nvSpPr>
        <p:spPr>
          <a:xfrm>
            <a:off x="147294" y="104175"/>
            <a:ext cx="15811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uppieren 6">
            <a:extLst>
              <a:ext uri="{FF2B5EF4-FFF2-40B4-BE49-F238E27FC236}">
                <a16:creationId xmlns:a16="http://schemas.microsoft.com/office/drawing/2014/main" xmlns="" id="{69095A05-4BBB-4135-85A1-97CF7A557D63}"/>
              </a:ext>
            </a:extLst>
          </p:cNvPr>
          <p:cNvGrpSpPr/>
          <p:nvPr/>
        </p:nvGrpSpPr>
        <p:grpSpPr>
          <a:xfrm>
            <a:off x="951230" y="683260"/>
            <a:ext cx="5996014" cy="4451350"/>
            <a:chOff x="730250" y="1003300"/>
            <a:chExt cx="5996014" cy="4451350"/>
          </a:xfrm>
        </p:grpSpPr>
        <p:pic>
          <p:nvPicPr>
            <p:cNvPr id="2" name="Grafik 1">
              <a:extLst>
                <a:ext uri="{FF2B5EF4-FFF2-40B4-BE49-F238E27FC236}">
                  <a16:creationId xmlns:a16="http://schemas.microsoft.com/office/drawing/2014/main" xmlns="" id="{98F632AF-8336-438E-80D4-F8E124FC1C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8927" t="7169" b="29277"/>
            <a:stretch/>
          </p:blipFill>
          <p:spPr>
            <a:xfrm>
              <a:off x="2019300" y="1003300"/>
              <a:ext cx="4706964" cy="3124200"/>
            </a:xfrm>
            <a:prstGeom prst="rect">
              <a:avLst/>
            </a:prstGeom>
          </p:spPr>
        </p:pic>
        <p:pic>
          <p:nvPicPr>
            <p:cNvPr id="59" name="Grafik 58">
              <a:extLst>
                <a:ext uri="{FF2B5EF4-FFF2-40B4-BE49-F238E27FC236}">
                  <a16:creationId xmlns:a16="http://schemas.microsoft.com/office/drawing/2014/main" xmlns="" id="{833C09CA-E337-42D4-BA3E-6CED4071C3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6299" t="74339" r="-1" b="84"/>
            <a:stretch/>
          </p:blipFill>
          <p:spPr>
            <a:xfrm>
              <a:off x="2400300" y="4197350"/>
              <a:ext cx="4325964" cy="1257300"/>
            </a:xfrm>
            <a:prstGeom prst="rect">
              <a:avLst/>
            </a:prstGeom>
          </p:spPr>
        </p:pic>
        <p:sp>
          <p:nvSpPr>
            <p:cNvPr id="3" name="Textfeld 2">
              <a:extLst>
                <a:ext uri="{FF2B5EF4-FFF2-40B4-BE49-F238E27FC236}">
                  <a16:creationId xmlns:a16="http://schemas.microsoft.com/office/drawing/2014/main" xmlns="" id="{6F6259CD-EA21-426E-A10A-A302A96DF8C0}"/>
                </a:ext>
              </a:extLst>
            </p:cNvPr>
            <p:cNvSpPr txBox="1"/>
            <p:nvPr/>
          </p:nvSpPr>
          <p:spPr>
            <a:xfrm>
              <a:off x="730250" y="4381423"/>
              <a:ext cx="1670050" cy="8227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PFB</a:t>
              </a:r>
            </a:p>
            <a:p>
              <a:pPr algn="r">
                <a:lnSpc>
                  <a:spcPct val="150000"/>
                </a:lnSpc>
              </a:pP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PFSE, </a:t>
              </a:r>
              <a:r>
                <a:rPr lang="de-DE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TERT</a:t>
              </a: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mut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PFSE, </a:t>
              </a:r>
              <a:r>
                <a:rPr lang="de-DE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TERT</a:t>
              </a: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 WT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feld 59">
              <a:extLst>
                <a:ext uri="{FF2B5EF4-FFF2-40B4-BE49-F238E27FC236}">
                  <a16:creationId xmlns:a16="http://schemas.microsoft.com/office/drawing/2014/main" xmlns="" id="{9D75DD1B-11FF-4E73-ACC8-30D1EE3E5F4B}"/>
                </a:ext>
              </a:extLst>
            </p:cNvPr>
            <p:cNvSpPr txBox="1"/>
            <p:nvPr/>
          </p:nvSpPr>
          <p:spPr>
            <a:xfrm>
              <a:off x="3996336" y="2644600"/>
              <a:ext cx="1670050" cy="3351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PFB</a:t>
              </a:r>
            </a:p>
          </p:txBody>
        </p:sp>
        <p:sp>
          <p:nvSpPr>
            <p:cNvPr id="4" name="Rechteck 3">
              <a:extLst>
                <a:ext uri="{FF2B5EF4-FFF2-40B4-BE49-F238E27FC236}">
                  <a16:creationId xmlns:a16="http://schemas.microsoft.com/office/drawing/2014/main" xmlns="" id="{EA668244-8D3C-428E-99BA-991963407A54}"/>
                </a:ext>
              </a:extLst>
            </p:cNvPr>
            <p:cNvSpPr/>
            <p:nvPr/>
          </p:nvSpPr>
          <p:spPr>
            <a:xfrm>
              <a:off x="4421879" y="3543089"/>
              <a:ext cx="1372940" cy="33515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PFSE, </a:t>
              </a:r>
              <a:r>
                <a:rPr lang="de-DE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TERT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ut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Rechteck 4">
              <a:extLst>
                <a:ext uri="{FF2B5EF4-FFF2-40B4-BE49-F238E27FC236}">
                  <a16:creationId xmlns:a16="http://schemas.microsoft.com/office/drawing/2014/main" xmlns="" id="{2990D69A-2071-435D-A460-E33A7B3B0CF9}"/>
                </a:ext>
              </a:extLst>
            </p:cNvPr>
            <p:cNvSpPr/>
            <p:nvPr/>
          </p:nvSpPr>
          <p:spPr>
            <a:xfrm>
              <a:off x="4831361" y="1003300"/>
              <a:ext cx="1356910" cy="33515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PFSE, </a:t>
              </a:r>
              <a:r>
                <a:rPr lang="de-DE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TERT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WT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Rechteck 5">
              <a:extLst>
                <a:ext uri="{FF2B5EF4-FFF2-40B4-BE49-F238E27FC236}">
                  <a16:creationId xmlns:a16="http://schemas.microsoft.com/office/drawing/2014/main" xmlns="" id="{F481867B-7C97-4CB2-83E2-145D094D1B2B}"/>
                </a:ext>
              </a:extLst>
            </p:cNvPr>
            <p:cNvSpPr/>
            <p:nvPr/>
          </p:nvSpPr>
          <p:spPr>
            <a:xfrm rot="16200000">
              <a:off x="990619" y="2397821"/>
              <a:ext cx="1957587" cy="33515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Progression-Free Survival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1" name="Rechteck 60">
            <a:extLst>
              <a:ext uri="{FF2B5EF4-FFF2-40B4-BE49-F238E27FC236}">
                <a16:creationId xmlns:a16="http://schemas.microsoft.com/office/drawing/2014/main" xmlns="" id="{ACCEEC24-E53F-4BE2-9724-BE2DDF28121D}"/>
              </a:ext>
            </a:extLst>
          </p:cNvPr>
          <p:cNvSpPr/>
          <p:nvPr/>
        </p:nvSpPr>
        <p:spPr>
          <a:xfrm>
            <a:off x="309965" y="5663813"/>
            <a:ext cx="8524067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: P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rogression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-free survival of 49 PFSE tumors according to </a:t>
            </a:r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TERT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mutation status in comparison to 137 PFB ependymomas.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TER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mutated PFSE tumors show significantly worse progression-free survival compared to 137 PFB ependymomas (log-rank test, p&lt;0.0001).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0770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3</Words>
  <Application>Microsoft Office PowerPoint</Application>
  <PresentationFormat>On-screen Show (4:3)</PresentationFormat>
  <Paragraphs>2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ian Thomas</dc:creator>
  <cp:lastModifiedBy>Aswini RV.</cp:lastModifiedBy>
  <cp:revision>11</cp:revision>
  <cp:lastPrinted>2021-01-12T15:42:45Z</cp:lastPrinted>
  <dcterms:created xsi:type="dcterms:W3CDTF">2021-01-09T22:43:15Z</dcterms:created>
  <dcterms:modified xsi:type="dcterms:W3CDTF">2021-03-18T02:55:23Z</dcterms:modified>
</cp:coreProperties>
</file>